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73" d="100"/>
          <a:sy n="73" d="100"/>
        </p:scale>
        <p:origin x="364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B81B1D5-209E-4406-8263-4FA16714E478}" type="datetimeFigureOut">
              <a:rPr lang="it-IT" smtClean="0"/>
              <a:t>31/03/2026</a:t>
            </a:fld>
            <a:endParaRPr lang="it-I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F8C4F7E-1FFD-4B26-ACB4-5C57F33914C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298168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8C4F7E-1FFD-4B26-ACB4-5C57F33914C3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127604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2C0B59-1A74-02BC-EDB6-E964CCF8DA5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it-IT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E2386E1-3DAC-7EED-0B47-0ABF93862CC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283D0D-53F5-5D33-EA2F-9CF7F47ABE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BF603-0C73-45D1-B886-FAB259DB1B0E}" type="datetimeFigureOut">
              <a:rPr lang="it-IT" smtClean="0"/>
              <a:t>31/03/2026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25AFA3-A69D-AB05-FDCD-29265FA45D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1C450F-5815-10B7-D202-8591FAFF7E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9C9C4-A080-43AD-A4F9-A2E61CFB303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927458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458A5A-1ECD-1303-A902-8522CDFD2A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it-I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51F1CF2-7BA8-9082-1243-651D146FD6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9E710E-673E-A586-CFD5-1AB20E0A68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BF603-0C73-45D1-B886-FAB259DB1B0E}" type="datetimeFigureOut">
              <a:rPr lang="it-IT" smtClean="0"/>
              <a:t>31/03/2026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161EBD-9CD8-84D2-A21B-722863FC06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D773F6-1D50-4D2D-287A-2F03847385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9C9C4-A080-43AD-A4F9-A2E61CFB303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08396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B75F42E-EBB7-C1A5-B566-A2FFA4C17AD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it-I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6444D25-E902-A9BE-8548-E7DE7AED16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6E33C5-6A27-3012-B968-2C449460AA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BF603-0C73-45D1-B886-FAB259DB1B0E}" type="datetimeFigureOut">
              <a:rPr lang="it-IT" smtClean="0"/>
              <a:t>31/03/2026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46A485-7D55-2F79-B7D0-DF52876AED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FF68E7-68D1-6A3C-FE43-5A217ECD7D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9C9C4-A080-43AD-A4F9-A2E61CFB303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688565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A5CC28-9FC2-49A5-4F06-52F789645A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it-I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A1C12A-23F9-1675-2014-19E119A97D9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3ABDAB-0C30-5E0F-A3A9-543C2549E3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BF603-0C73-45D1-B886-FAB259DB1B0E}" type="datetimeFigureOut">
              <a:rPr lang="it-IT" smtClean="0"/>
              <a:t>31/03/2026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927315-9B82-81B9-8A24-75BE0B851A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77C23A-CD34-0AA9-17CD-4D8CC03C14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9C9C4-A080-43AD-A4F9-A2E61CFB303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646917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4E9D72-C0BB-4BC6-CB4A-5FFAE58718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it-I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EB841D1-C27F-204A-A9F3-DB3BC6B5D2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A32D9C-7BBA-E1A1-68B3-DF7800561C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BF603-0C73-45D1-B886-FAB259DB1B0E}" type="datetimeFigureOut">
              <a:rPr lang="it-IT" smtClean="0"/>
              <a:t>31/03/2026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5AB0C6-DCAD-DB72-0D14-6FEE80AA33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09D209-E5C9-5896-52CA-B32C93ABB6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9C9C4-A080-43AD-A4F9-A2E61CFB303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556879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41077E-59D5-2094-2E73-D303EF716C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it-I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88DD30-5505-5761-9311-E9069E1364A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it-IT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C6A571D-6FD0-DF8A-3B1B-7C4E7BB909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it-IT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873B836-715B-85E1-DF22-AB247B84F9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BF603-0C73-45D1-B886-FAB259DB1B0E}" type="datetimeFigureOut">
              <a:rPr lang="it-IT" smtClean="0"/>
              <a:t>31/03/2026</a:t>
            </a:fld>
            <a:endParaRPr lang="it-I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6A85815-8B64-4007-E9EE-27E1B2A2C1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D6FAA9-BE0C-D19D-0848-AE71687C60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9C9C4-A080-43AD-A4F9-A2E61CFB303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18816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C554FF-4F20-9E2C-2EE3-43AE391D7D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it-I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88BEB6-5D0D-A0CC-ECEC-7853F353A3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E1B8E8B-C31E-8318-2912-0CDD270808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it-IT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09961B1-C659-1D8E-B7B8-5FBCCC7AD39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849BFAC-E2B1-A294-225B-D7D10E45D45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it-IT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DFF9E80-9CD2-6837-4F0F-E825621810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BF603-0C73-45D1-B886-FAB259DB1B0E}" type="datetimeFigureOut">
              <a:rPr lang="it-IT" smtClean="0"/>
              <a:t>31/03/2026</a:t>
            </a:fld>
            <a:endParaRPr lang="it-IT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FA3E85D-D4AC-0FF7-8D71-0D610DB724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DAD7254-1494-CF78-E837-C43807BAB8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9C9C4-A080-43AD-A4F9-A2E61CFB303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951618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2F6A7E-AE22-1A91-4840-2ECD80D8FA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it-IT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BF92044-8B6A-EB36-788E-561DC01CCA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BF603-0C73-45D1-B886-FAB259DB1B0E}" type="datetimeFigureOut">
              <a:rPr lang="it-IT" smtClean="0"/>
              <a:t>31/03/2026</a:t>
            </a:fld>
            <a:endParaRPr lang="it-IT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8CDD75A-9931-1CD8-E218-011D5BF283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C889B90-1596-3E3B-4A77-8CCEB5F92D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9C9C4-A080-43AD-A4F9-A2E61CFB303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049629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123AC4A-05B6-76F9-9F45-D772D41986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BF603-0C73-45D1-B886-FAB259DB1B0E}" type="datetimeFigureOut">
              <a:rPr lang="it-IT" smtClean="0"/>
              <a:t>31/03/2026</a:t>
            </a:fld>
            <a:endParaRPr lang="it-IT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E445A54-2540-8DE8-847C-98E18B5FEA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15C052E-1205-4B04-97DF-A7A7807938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9C9C4-A080-43AD-A4F9-A2E61CFB303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732172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E514E9-DC30-F354-0B8E-7037041200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it-I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94AF22-74B5-FF63-4677-7577D19497B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it-I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05897A-9EA8-8BAC-9C51-4FC567669E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3CB443-28D1-4953-6286-0D1AA80CE4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BF603-0C73-45D1-B886-FAB259DB1B0E}" type="datetimeFigureOut">
              <a:rPr lang="it-IT" smtClean="0"/>
              <a:t>31/03/2026</a:t>
            </a:fld>
            <a:endParaRPr lang="it-I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0F799C-65F4-89D3-7F13-95A17DDFC1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4E3997-90FC-9851-3F6E-4B372D884A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9C9C4-A080-43AD-A4F9-A2E61CFB303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275310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E9C0AD-DF13-95D3-7853-71CC729A64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it-IT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86192DC-B7A2-E186-4603-29335E8695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DF09E96-876E-39AD-A6A0-477CB823B2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5483081-F5FF-61F6-32D0-A4B46A3A2C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BF603-0C73-45D1-B886-FAB259DB1B0E}" type="datetimeFigureOut">
              <a:rPr lang="it-IT" smtClean="0"/>
              <a:t>31/03/2026</a:t>
            </a:fld>
            <a:endParaRPr lang="it-I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5F0F1C-B989-EF07-02DB-8A09D35F8D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A156280-FB44-23B7-BD2F-B9D336DBA2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9C9C4-A080-43AD-A4F9-A2E61CFB303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240956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64BBCD0-C83A-A37A-D426-4015A002C0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it-I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709838-AF76-059E-6920-944A5E7251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779AB5-902F-8DD3-FE9F-162EFC20527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41BF603-0C73-45D1-B886-FAB259DB1B0E}" type="datetimeFigureOut">
              <a:rPr lang="it-IT" smtClean="0"/>
              <a:t>31/03/2026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C37E74-1B3D-6F76-7C37-20C6994F2FF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EA99E4-45BB-17E4-7D36-1BF1654E95F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069C9C4-A080-43AD-A4F9-A2E61CFB303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593938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BDC986F-C931-5761-032E-D9CE55146AE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437" y="714105"/>
            <a:ext cx="3334716" cy="3168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985C1A8-2845-B470-7251-0A7D23BD0EF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09117" y="714105"/>
            <a:ext cx="3424857" cy="3168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E2FFD0E0-018C-4AE7-2225-EE14FD993DD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96092" y="714105"/>
            <a:ext cx="3510269" cy="3168000"/>
          </a:xfrm>
          <a:prstGeom prst="rect">
            <a:avLst/>
          </a:prstGeom>
        </p:spPr>
      </p:pic>
      <p:sp>
        <p:nvSpPr>
          <p:cNvPr id="10" name="CasellaDiTesto 1">
            <a:extLst>
              <a:ext uri="{FF2B5EF4-FFF2-40B4-BE49-F238E27FC236}">
                <a16:creationId xmlns:a16="http://schemas.microsoft.com/office/drawing/2014/main" id="{6C29DBCB-828F-99FC-AAF2-A898529B3390}"/>
              </a:ext>
            </a:extLst>
          </p:cNvPr>
          <p:cNvSpPr txBox="1"/>
          <p:nvPr/>
        </p:nvSpPr>
        <p:spPr>
          <a:xfrm>
            <a:off x="500835" y="256833"/>
            <a:ext cx="3135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CasellaDiTesto 2">
            <a:extLst>
              <a:ext uri="{FF2B5EF4-FFF2-40B4-BE49-F238E27FC236}">
                <a16:creationId xmlns:a16="http://schemas.microsoft.com/office/drawing/2014/main" id="{81A44144-06FA-657D-B6E0-A1F1C36B410A}"/>
              </a:ext>
            </a:extLst>
          </p:cNvPr>
          <p:cNvSpPr txBox="1"/>
          <p:nvPr/>
        </p:nvSpPr>
        <p:spPr>
          <a:xfrm>
            <a:off x="4124178" y="252477"/>
            <a:ext cx="3135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CasellaDiTesto 6">
            <a:extLst>
              <a:ext uri="{FF2B5EF4-FFF2-40B4-BE49-F238E27FC236}">
                <a16:creationId xmlns:a16="http://schemas.microsoft.com/office/drawing/2014/main" id="{C9C226D6-E5BC-B14A-3022-C8C3AC942A43}"/>
              </a:ext>
            </a:extLst>
          </p:cNvPr>
          <p:cNvSpPr txBox="1"/>
          <p:nvPr/>
        </p:nvSpPr>
        <p:spPr>
          <a:xfrm>
            <a:off x="7932669" y="256829"/>
            <a:ext cx="3135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8777011-DCE2-B7DA-F21F-B8E2A26AE91F}"/>
              </a:ext>
            </a:extLst>
          </p:cNvPr>
          <p:cNvSpPr txBox="1"/>
          <p:nvPr/>
        </p:nvSpPr>
        <p:spPr>
          <a:xfrm>
            <a:off x="518437" y="4824952"/>
            <a:ext cx="10987924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  <a:buNone/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1. Analysis of antibacterial activity of WJ-MSC-CM against </a:t>
            </a:r>
            <a:r>
              <a:rPr lang="en-US" sz="12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. aeruginosa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epresentative images of agar diffusion assay plates inoculated with bacteria are shown for the experimental groups, including meropenem as a positive control. Antibacterial activity was evaluated by the presence of a halo of inhibition, and the corresponding graph reports the diameter of the inhibition halo expressed in millimeters (mm): (A) culture medium alone (Group 1) and WJ-MSC-CM (Group 2); (B) conditioned media from untreated fibroblasts in the absence (Group 3) or presence (Group 4) of H₂O₂; and (C) conditioned media from WJ-MSC-CM–treated fibroblasts in the absence (Group 5) or presence (Group 6) of H₂O₂. </a:t>
            </a:r>
            <a:endParaRPr lang="it-IT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27741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46</Words>
  <Application>Microsoft Office PowerPoint</Application>
  <PresentationFormat>Widescreen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Filomena Napolitano</dc:creator>
  <cp:lastModifiedBy>Filomena Napolitano</cp:lastModifiedBy>
  <cp:revision>4</cp:revision>
  <dcterms:created xsi:type="dcterms:W3CDTF">2026-03-31T07:34:43Z</dcterms:created>
  <dcterms:modified xsi:type="dcterms:W3CDTF">2026-03-31T07:42:28Z</dcterms:modified>
</cp:coreProperties>
</file>